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8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B6316E-520B-F7BD-DABD-C7836545D5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916652D-0A85-D39A-11F4-FC3BDEED31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CB303B-8090-CBC0-A134-40ED9A145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009A49-CB76-3A58-38FB-665B4038CF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EAFCD8-F148-4E2A-864E-5C153C3AD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45053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7CD0AF-F855-3C82-A2F1-37A31C97A9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7970AA-8C7B-DB20-0C88-E6173C8A3E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9C4A38-F8D2-BFC9-048C-782C96BCF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1F9E06-BB92-E7C4-21DB-06DED6DB6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1827B-D9EF-BFA6-328E-D2A1908F8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51769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C3ADD7-7835-689F-AA18-2836F528A8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986934-FAA3-4183-756A-0DC1B1BA02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4CCA35-1215-79E6-DF9D-0C4B71A66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FF00F4-4EB0-555B-7BC3-F88FFA217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BF7A64-5395-8BAA-9BCC-0C45D939A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3692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701946-959F-B102-AAFF-1DF9F13E83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54E578-991D-EE0B-2133-BDB3475215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8CA745-5212-C640-1716-1D2ADCFEF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9AFB84-0DB8-C12F-1D13-47E242FEF3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59FDA0-5A0F-9E9E-D4F9-85CF9C0B6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51393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ABE787-B994-69DA-00F8-1D0C7C4AB2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CDAD15-7892-244C-518A-2CD5851F81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8DB910-D036-5696-542F-12BF37D52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E71E0C-23AA-5277-86C7-B2DFC44F6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3A77CC-291F-522D-3133-2FD0372EB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26900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BC0A0C-587C-E1F3-239E-BAE48A557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D6BCD6-1E06-18B1-1BE1-86723A2970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2F6E08-8377-DED1-22D3-6F06D30245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C536F5-6379-CCA1-3A77-92BCD485D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B2485F-30C7-40F3-25EA-713DFCCEC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2F2E7E-3E07-4426-8EC6-056B4FC98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1320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B3EB4F-9262-7A27-CF5E-29EE8A903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8516EA-5C9B-9110-F65E-C2DCF08054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838E69-8C0D-F2F4-9FD5-856382B13C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6DC506-1EDF-1E6D-5EF0-61A9276628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53FE03-2EFF-9A55-E6B1-0468DAA9B1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FA42B8-922E-F4BF-6F04-8B611E5BE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6D9BCF-C118-8774-F239-74B5314A4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45B6AE8-F924-0110-EC20-3F5622385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98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47B5D-9A51-85A0-921B-7088D579AE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1D09D72-A4F6-004B-77EE-37B807324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6BFDE50-9062-F961-1B94-472955A62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2A633B9-9FD6-34CC-2403-729D19D5D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4949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CEC93D-BD94-7014-F9E7-2BCFADDA4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11AA23-62CE-B813-F28E-73863A00B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34BFF5-013B-B616-66B5-5EC493DAE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1073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03EBB7-EA0D-CE0D-A3E5-96268DED1C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B1B753-B619-80CD-61B8-73F82CD91E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7091E3-CE72-3319-22D4-2BCD45FDF4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35F765-4F06-AC3D-0845-09A21A6AC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72FB61-1E28-2248-C13F-AA019971E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000B8-E634-1427-DF37-7ABFB89A3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44408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AA2A80-0A69-089E-03B3-49B6F71C6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E8B2C0-C61B-CC12-5F74-46D8E6A303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3954DD-E900-F9BE-4A7D-01DA528176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B7F8B2-6563-7C78-D4F1-DFFB7030E1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E64EAF-7030-8D00-3581-0A7E7233A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9FF413-3775-E72B-F3EA-5C6D0A0C0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4323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9C2ABB-E8D5-FC6E-CF0E-DCA64F7ACC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8F6F5F-3764-B082-575C-4A9110EB46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E5D5BA-F8AC-F233-C6E8-1F6F6D8EDF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4114836-7D77-CD46-8133-0F372F590BC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8677CA-7011-56BC-4FF8-4121D0D60F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E5E79C-EABA-49B4-10DA-6C9FCD1EE7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C135FF-9125-5742-82BC-AA9A9FBD53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39058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A2CFA0A-A25E-40F1-A8DA-75D974EDB12C}"/>
              </a:ext>
            </a:extLst>
          </p:cNvPr>
          <p:cNvGrpSpPr/>
          <p:nvPr/>
        </p:nvGrpSpPr>
        <p:grpSpPr>
          <a:xfrm>
            <a:off x="464214" y="343696"/>
            <a:ext cx="4920586" cy="5126245"/>
            <a:chOff x="464214" y="343696"/>
            <a:chExt cx="4920586" cy="512624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B8BE858-EB16-409D-B552-5B181495BB4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grayscl/>
            </a:blip>
            <a:stretch>
              <a:fillRect/>
            </a:stretch>
          </p:blipFill>
          <p:spPr>
            <a:xfrm>
              <a:off x="473092" y="343696"/>
              <a:ext cx="3091375" cy="1610805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F694A3C-90F0-4F60-8E90-3B216FE94C2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grayscl/>
            </a:blip>
            <a:stretch>
              <a:fillRect/>
            </a:stretch>
          </p:blipFill>
          <p:spPr>
            <a:xfrm>
              <a:off x="464625" y="1952907"/>
              <a:ext cx="2845841" cy="82621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864DCA2-D57B-498A-91E8-CBDC44D019D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grayscl/>
            </a:blip>
            <a:stretch>
              <a:fillRect/>
            </a:stretch>
          </p:blipFill>
          <p:spPr>
            <a:xfrm>
              <a:off x="464214" y="3850750"/>
              <a:ext cx="3757683" cy="628117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862BF3B-7EB8-4712-A8E4-53D296CED47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grayscl/>
            </a:blip>
            <a:stretch>
              <a:fillRect/>
            </a:stretch>
          </p:blipFill>
          <p:spPr>
            <a:xfrm>
              <a:off x="481559" y="4485564"/>
              <a:ext cx="3540107" cy="201987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398C15E-2C32-4A1B-9306-A55B480D773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grayscl/>
            </a:blip>
            <a:stretch>
              <a:fillRect/>
            </a:stretch>
          </p:blipFill>
          <p:spPr>
            <a:xfrm>
              <a:off x="473503" y="4675569"/>
              <a:ext cx="4911297" cy="46295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2B4DDCF-543C-4EEE-B6CB-0696448AA6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grayscl/>
            </a:blip>
            <a:srcRect l="13330" t="-3643" b="-1"/>
            <a:stretch/>
          </p:blipFill>
          <p:spPr>
            <a:xfrm>
              <a:off x="496740" y="5134910"/>
              <a:ext cx="3749781" cy="149117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9F2770B-6423-4310-BFB6-6510FC7D163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grayscl/>
            </a:blip>
            <a:stretch>
              <a:fillRect/>
            </a:stretch>
          </p:blipFill>
          <p:spPr>
            <a:xfrm>
              <a:off x="469279" y="5309253"/>
              <a:ext cx="3106632" cy="160688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5AA0DE9-E71C-4D01-A9C9-95244CAE960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grayscl/>
            </a:blip>
            <a:stretch>
              <a:fillRect/>
            </a:stretch>
          </p:blipFill>
          <p:spPr>
            <a:xfrm>
              <a:off x="478598" y="2790190"/>
              <a:ext cx="2986025" cy="1062143"/>
            </a:xfrm>
            <a:prstGeom prst="rect">
              <a:avLst/>
            </a:prstGeom>
          </p:spPr>
        </p:pic>
      </p:grpSp>
      <p:sp>
        <p:nvSpPr>
          <p:cNvPr id="13" name="Text Box 2">
            <a:extLst>
              <a:ext uri="{FF2B5EF4-FFF2-40B4-BE49-F238E27FC236}">
                <a16:creationId xmlns:a16="http://schemas.microsoft.com/office/drawing/2014/main" id="{0D95C03F-0596-41C2-AE0E-FF56DC8A04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029" y="5591206"/>
            <a:ext cx="4648200" cy="80904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Additional File 6: Collagenous fragments obtained from LC-MS data of extracted 17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kDa</a:t>
            </a:r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 band from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A. </a:t>
            </a:r>
            <a:r>
              <a:rPr lang="en-US" sz="1200" b="1" i="1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niger</a:t>
            </a:r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 isolate TM4.2.1. 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Underlined proline (P) residues are confirmed for hydroxylation (oxidation).</a:t>
            </a:r>
            <a:endParaRPr lang="en-DE" sz="1200" dirty="0">
              <a:effectLst/>
              <a:latin typeface="Helvetica" pitchFamily="2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2116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5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U-Pseudonym 1517372033116741</dc:creator>
  <cp:lastModifiedBy>TU-Pseudonym 1517372033116741</cp:lastModifiedBy>
  <cp:revision>1</cp:revision>
  <dcterms:created xsi:type="dcterms:W3CDTF">2025-07-15T18:41:52Z</dcterms:created>
  <dcterms:modified xsi:type="dcterms:W3CDTF">2025-07-15T18:44:52Z</dcterms:modified>
</cp:coreProperties>
</file>